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9" r:id="rId1"/>
  </p:sldMasterIdLst>
  <p:notesMasterIdLst>
    <p:notesMasterId r:id="rId3"/>
  </p:notesMasterIdLst>
  <p:sldIdLst>
    <p:sldId id="1910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11893"/>
    <a:srgbClr val="FF9300"/>
    <a:srgbClr val="FF2F92"/>
    <a:srgbClr val="009040"/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E3FDE45-AF77-4B5C-9715-49D594BDF05E}" styleName="淡色スタイル 1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060" autoAdjust="0"/>
    <p:restoredTop sz="61398" autoAdjust="0"/>
  </p:normalViewPr>
  <p:slideViewPr>
    <p:cSldViewPr snapToGrid="0">
      <p:cViewPr varScale="1">
        <p:scale>
          <a:sx n="76" d="100"/>
          <a:sy n="76" d="100"/>
        </p:scale>
        <p:origin x="200" y="192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-15752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JSOG2024 PCOS 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Total</c:v>
                </c:pt>
                <c:pt idx="1">
                  <c:v>BMI ≥25</c:v>
                </c:pt>
                <c:pt idx="2">
                  <c:v>BMI &lt;25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78.900000000000006</c:v>
                </c:pt>
                <c:pt idx="1">
                  <c:v>88.399999999999991</c:v>
                </c:pt>
                <c:pt idx="2">
                  <c:v>75.5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D7-CA45-9D2E-67F499C62C3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Rotterdam/IEBG2023 PCOS 
based on AMH, 
but not meeting JSOG2024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Total</c:v>
                </c:pt>
                <c:pt idx="1">
                  <c:v>BMI ≥25</c:v>
                </c:pt>
                <c:pt idx="2">
                  <c:v>BMI &lt;25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13.3</c:v>
                </c:pt>
                <c:pt idx="1">
                  <c:v>8.6999999999999993</c:v>
                </c:pt>
                <c:pt idx="2">
                  <c:v>14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FD7-CA45-9D2E-67F499C62C3D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Cases not meeting JSOG2024, 
nor Rotterdam/IEBG2023 
based on AMH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Total</c:v>
                </c:pt>
                <c:pt idx="1">
                  <c:v>BMI ≥25</c:v>
                </c:pt>
                <c:pt idx="2">
                  <c:v>BMI &lt;25</c:v>
                </c:pt>
              </c:strCache>
            </c:strRef>
          </c:cat>
          <c:val>
            <c:numRef>
              <c:f>Sheet1!$D$2:$D$4</c:f>
              <c:numCache>
                <c:formatCode>General</c:formatCode>
                <c:ptCount val="3"/>
                <c:pt idx="0">
                  <c:v>7.8</c:v>
                </c:pt>
                <c:pt idx="1">
                  <c:v>2.9</c:v>
                </c:pt>
                <c:pt idx="2">
                  <c:v>9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FD7-CA45-9D2E-67F499C62C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100"/>
        <c:axId val="907515391"/>
        <c:axId val="907485647"/>
      </c:barChart>
      <c:catAx>
        <c:axId val="9075153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7485647"/>
        <c:crossesAt val="0"/>
        <c:auto val="1"/>
        <c:lblAlgn val="ctr"/>
        <c:lblOffset val="100"/>
        <c:noMultiLvlLbl val="0"/>
      </c:catAx>
      <c:valAx>
        <c:axId val="907485647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General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751539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JSOG2024 PCOS 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Total</c:v>
                </c:pt>
                <c:pt idx="1">
                  <c:v>BMI ≥25</c:v>
                </c:pt>
                <c:pt idx="2">
                  <c:v>BMI &lt;25</c:v>
                </c:pt>
              </c:strCache>
            </c:strRef>
          </c:cat>
          <c:val>
            <c:numRef>
              <c:f>Sheet1!$B$2:$B$4</c:f>
              <c:numCache>
                <c:formatCode>0.0</c:formatCode>
                <c:ptCount val="3"/>
                <c:pt idx="0">
                  <c:v>73.703703703703709</c:v>
                </c:pt>
                <c:pt idx="1">
                  <c:v>78.260869565217391</c:v>
                </c:pt>
                <c:pt idx="2">
                  <c:v>72.1393034825870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A46-3448-ABF9-2C893FDB9D10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Rotterdam/IEBG2023 PCOS 
based on AMH, 
but not meeting JSOG2024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Total</c:v>
                </c:pt>
                <c:pt idx="1">
                  <c:v>BMI ≥25</c:v>
                </c:pt>
                <c:pt idx="2">
                  <c:v>BMI &lt;25</c:v>
                </c:pt>
              </c:strCache>
            </c:strRef>
          </c:cat>
          <c:val>
            <c:numRef>
              <c:f>Sheet1!$C$2:$C$4</c:f>
              <c:numCache>
                <c:formatCode>0.0</c:formatCode>
                <c:ptCount val="3"/>
                <c:pt idx="0">
                  <c:v>18.518518518518519</c:v>
                </c:pt>
                <c:pt idx="1">
                  <c:v>18.840579710144929</c:v>
                </c:pt>
                <c:pt idx="2">
                  <c:v>18.4079601990049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A46-3448-ABF9-2C893FDB9D10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Cases not meeting JSOG2024, 
nor Rotterdam/IEBG2023 
based on AMH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Total</c:v>
                </c:pt>
                <c:pt idx="1">
                  <c:v>BMI ≥25</c:v>
                </c:pt>
                <c:pt idx="2">
                  <c:v>BMI &lt;25</c:v>
                </c:pt>
              </c:strCache>
            </c:strRef>
          </c:cat>
          <c:val>
            <c:numRef>
              <c:f>Sheet1!$D$2:$D$4</c:f>
              <c:numCache>
                <c:formatCode>0.0</c:formatCode>
                <c:ptCount val="3"/>
                <c:pt idx="0">
                  <c:v>7.7777777777777777</c:v>
                </c:pt>
                <c:pt idx="1">
                  <c:v>2.8985507246376812</c:v>
                </c:pt>
                <c:pt idx="2">
                  <c:v>9.45273631840795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A46-3448-ABF9-2C893FDB9D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100"/>
        <c:axId val="907515391"/>
        <c:axId val="907485647"/>
      </c:barChart>
      <c:catAx>
        <c:axId val="9075153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7485647"/>
        <c:crossesAt val="0"/>
        <c:auto val="1"/>
        <c:lblAlgn val="ctr"/>
        <c:lblOffset val="100"/>
        <c:noMultiLvlLbl val="0"/>
      </c:catAx>
      <c:valAx>
        <c:axId val="907485647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General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751539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JSOG2024 PCOS 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Total</c:v>
                </c:pt>
                <c:pt idx="1">
                  <c:v>BMI ≥25</c:v>
                </c:pt>
                <c:pt idx="2">
                  <c:v>BMI &lt;25</c:v>
                </c:pt>
              </c:strCache>
            </c:strRef>
          </c:cat>
          <c:val>
            <c:numRef>
              <c:f>Sheet1!$B$2:$B$4</c:f>
              <c:numCache>
                <c:formatCode>0.0</c:formatCode>
                <c:ptCount val="3"/>
                <c:pt idx="0">
                  <c:v>82.222222222222214</c:v>
                </c:pt>
                <c:pt idx="1">
                  <c:v>85.507246376811594</c:v>
                </c:pt>
                <c:pt idx="2">
                  <c:v>81.0945273631840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40-E14C-839E-D68D3F22B1B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Rotterdam/IEBG2023 PCOS 
based on AMH, 
but not meeting JSOG2024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Total</c:v>
                </c:pt>
                <c:pt idx="1">
                  <c:v>BMI ≥25</c:v>
                </c:pt>
                <c:pt idx="2">
                  <c:v>BMI &lt;25</c:v>
                </c:pt>
              </c:strCache>
            </c:strRef>
          </c:cat>
          <c:val>
            <c:numRef>
              <c:f>Sheet1!$C$2:$C$4</c:f>
              <c:numCache>
                <c:formatCode>0.0</c:formatCode>
                <c:ptCount val="3"/>
                <c:pt idx="0">
                  <c:v>10</c:v>
                </c:pt>
                <c:pt idx="1">
                  <c:v>11.594202898550725</c:v>
                </c:pt>
                <c:pt idx="2">
                  <c:v>9.45273631840795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40-E14C-839E-D68D3F22B1B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Cases not meeting JSOG2024, 
nor Rotterdam/IEBG2023 
based on AMH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Total</c:v>
                </c:pt>
                <c:pt idx="1">
                  <c:v>BMI ≥25</c:v>
                </c:pt>
                <c:pt idx="2">
                  <c:v>BMI &lt;25</c:v>
                </c:pt>
              </c:strCache>
            </c:strRef>
          </c:cat>
          <c:val>
            <c:numRef>
              <c:f>Sheet1!$D$2:$D$4</c:f>
              <c:numCache>
                <c:formatCode>0.0</c:formatCode>
                <c:ptCount val="3"/>
                <c:pt idx="0">
                  <c:v>7.7777777777777777</c:v>
                </c:pt>
                <c:pt idx="1">
                  <c:v>2.8985507246376812</c:v>
                </c:pt>
                <c:pt idx="2">
                  <c:v>9.45273631840795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740-E14C-839E-D68D3F22B1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100"/>
        <c:axId val="907515391"/>
        <c:axId val="907485647"/>
      </c:barChart>
      <c:catAx>
        <c:axId val="9075153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7485647"/>
        <c:crossesAt val="0"/>
        <c:auto val="1"/>
        <c:lblAlgn val="ctr"/>
        <c:lblOffset val="100"/>
        <c:noMultiLvlLbl val="0"/>
      </c:catAx>
      <c:valAx>
        <c:axId val="907485647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General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751539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2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3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46887B-6B9D-48C2-9707-1CC601AFB4B1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0703A9-D83A-4EC9-9CB6-7BDB70FDB2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7794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F2283A-CFED-AB62-FD46-8149FA860A9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00303030-F98B-EF82-C4A5-A5A632AE11C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23D9A421-B8C9-EE26-D024-7049ABFCD4C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Proportions of patients diagnosed with PCOS according to the JSOG 2024 criteria and the Rotterdam/IEBG 2023 criteria in the overall population, the obese/overweight group (BMI ≥25 kg/m²), and the non-obese/overweight group (BMI &lt;25 kg/m²)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cording to the JSOG 2024 criteria, 78.9% of the overall population was diagnosed with PCOS (88.4% and 75.6% in the obese/overweight and non-obese/overweight groups, respectively). 13.3% was additionally diagnosed with PCOS according to the Rotterdam/IEBG 2023 criteria applying elevated serum AMH (level 2), defined as an AMH level above the cut-off value level 2 with a specificity of ≥95% </a:t>
            </a:r>
            <a:r>
              <a:rPr kumimoji="1" lang="en-US" altLang="ja-JP" sz="1200" kern="1200" dirty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(</a:t>
            </a:r>
            <a:r>
              <a:rPr kumimoji="1" lang="en-US" altLang="ja-JP" sz="1200" kern="120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Table 1)</a:t>
            </a:r>
            <a:r>
              <a:rPr kumimoji="1" lang="en-US" altLang="ja-JP" sz="1200" kern="1200" baseline="3000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26</a:t>
            </a:r>
            <a:r>
              <a:rPr kumimoji="1" lang="en-US" altLang="ja-JP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8.7% and 14.9% in the obese/overweight and non-obese/overweight groups, respectively) (a)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cording to the Rotterdam/IEBG 2023 criteria based on elevated serum AMH (level 2), 73.7% of the overall population was diagnosed with PCOS (78.3% and 72.1% in the obese/overweight and non-obese/overweight groups, respectively). 18.5% was additionally diagnosed with PCOS according to the JSOG 2024 criteria based on hyperandrogenism and/or high LH (18.8% and 18.4% in the obese/overweight and non-obese/overweight groups, respectively) (b)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cording to the Rotterdam/IEBG 2023 criteria based on elevated serum AMH (level 2) and/or hyperandrogenism, 82.2% of the overall population was diagnosed with PCOS (85.5% and 81.1% in the obese/overweight and non-obese/overweight groups, respectively). 10.0% was additionally diagnosed with PCOS according to the JSOG 2024 criteria based on high LH (11.6% and 9.5% in the obese/overweight and non-obese/overweight groups, respectively) (c)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7D53E35-4CF4-036D-A594-A608631A69B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90703A9-D83A-4EC9-9CB6-7BDB70FDB28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22603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4530"/>
            <a:ext cx="9144000" cy="2387600"/>
          </a:xfrm>
        </p:spPr>
        <p:txBody>
          <a:bodyPr anchor="b">
            <a:normAutofit/>
          </a:bodyPr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 algn="ctr">
              <a:buNone/>
              <a:defRPr sz="2800"/>
            </a:lvl2pPr>
            <a:lvl3pPr marL="914400" indent="0" algn="ctr">
              <a:buNone/>
              <a:defRPr sz="24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2972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0560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0362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0362"/>
            <a:ext cx="7734300" cy="581183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116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7021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12423"/>
            <a:ext cx="10515600" cy="2851208"/>
          </a:xfrm>
        </p:spPr>
        <p:txBody>
          <a:bodyPr anchor="b">
            <a:normAutofit/>
          </a:bodyPr>
          <a:lstStyle>
            <a:lvl1pPr>
              <a:defRPr sz="60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52633"/>
            <a:ext cx="10515600" cy="1500187"/>
          </a:xfrm>
        </p:spPr>
        <p:txBody>
          <a:bodyPr anchor="t">
            <a:normAutofit/>
          </a:bodyPr>
          <a:lstStyle>
            <a:lvl1pPr marL="0" indent="0">
              <a:buNone/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5890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45127" y="1828800"/>
            <a:ext cx="51816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8800"/>
            <a:ext cx="51816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7766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5127" y="1681850"/>
            <a:ext cx="5156200" cy="825699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45127" y="2507550"/>
            <a:ext cx="5156200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851"/>
            <a:ext cx="5181601" cy="825698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7550"/>
            <a:ext cx="5181601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4069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903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7667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1248" y="457200"/>
            <a:ext cx="3931920" cy="1600197"/>
          </a:xfrm>
        </p:spPr>
        <p:txBody>
          <a:bodyPr anchor="b">
            <a:normAutofit/>
          </a:bodyPr>
          <a:lstStyle>
            <a:lvl1pPr>
              <a:defRPr sz="32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1600" y="990600"/>
            <a:ext cx="6172200" cy="48768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1248" y="2057399"/>
            <a:ext cx="3931920" cy="3810001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4897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1248" y="457200"/>
            <a:ext cx="3931920" cy="1600200"/>
          </a:xfrm>
        </p:spPr>
        <p:txBody>
          <a:bodyPr anchor="b">
            <a:normAutofit/>
          </a:bodyPr>
          <a:lstStyle>
            <a:lvl1pPr>
              <a:defRPr sz="32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1600" y="990600"/>
            <a:ext cx="6172200" cy="4876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1248" y="2057400"/>
            <a:ext cx="3931920" cy="38100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395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45127" y="365760"/>
            <a:ext cx="10515600" cy="13255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5127" y="1828800"/>
            <a:ext cx="10515600" cy="43513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C8539EB7-E9A3-40B5-BC30-CC988B40EA69}" type="datetimeFigureOut">
              <a:rPr kumimoji="1" lang="ja-JP" altLang="en-US" smtClean="0"/>
              <a:t>2026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7527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49D78-2C8B-4866-AE37-AB31487CE4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8997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0" r:id="rId1"/>
    <p:sldLayoutId id="2147483691" r:id="rId2"/>
    <p:sldLayoutId id="2147483692" r:id="rId3"/>
    <p:sldLayoutId id="2147483693" r:id="rId4"/>
    <p:sldLayoutId id="2147483694" r:id="rId5"/>
    <p:sldLayoutId id="2147483695" r:id="rId6"/>
    <p:sldLayoutId id="2147483696" r:id="rId7"/>
    <p:sldLayoutId id="2147483697" r:id="rId8"/>
    <p:sldLayoutId id="2147483698" r:id="rId9"/>
    <p:sldLayoutId id="2147483699" r:id="rId10"/>
    <p:sldLayoutId id="2147483700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Wingdings 2" pitchFamily="18" charset="2"/>
        <a:buChar char="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 2" pitchFamily="18" charset="2"/>
        <a:buChar char="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 2" pitchFamily="18" charset="2"/>
        <a:buChar char="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D3055F5-F889-4DDF-CF6E-8BD2EB01F3B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A117B042-575F-60E7-D1BF-E79A60D005AC}"/>
              </a:ext>
            </a:extLst>
          </p:cNvPr>
          <p:cNvGraphicFramePr/>
          <p:nvPr/>
        </p:nvGraphicFramePr>
        <p:xfrm>
          <a:off x="461668" y="505198"/>
          <a:ext cx="3826128" cy="37987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5B907372-1B8F-C492-D2DC-DE178034A699}"/>
              </a:ext>
            </a:extLst>
          </p:cNvPr>
          <p:cNvGraphicFramePr/>
          <p:nvPr/>
        </p:nvGraphicFramePr>
        <p:xfrm>
          <a:off x="4382750" y="505198"/>
          <a:ext cx="3826128" cy="37987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2BF9B36D-2AC5-822A-5B6A-25BD06A6A707}"/>
              </a:ext>
            </a:extLst>
          </p:cNvPr>
          <p:cNvGraphicFramePr/>
          <p:nvPr/>
        </p:nvGraphicFramePr>
        <p:xfrm>
          <a:off x="8303832" y="505198"/>
          <a:ext cx="3826128" cy="37987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D0151AA-7694-2AA0-274F-E665013B7EFE}"/>
              </a:ext>
            </a:extLst>
          </p:cNvPr>
          <p:cNvSpPr txBox="1"/>
          <p:nvPr/>
        </p:nvSpPr>
        <p:spPr>
          <a:xfrm>
            <a:off x="237601" y="6906"/>
            <a:ext cx="14127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(a) 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65DD6F8-E044-7FFA-14FD-20B96371C484}"/>
              </a:ext>
            </a:extLst>
          </p:cNvPr>
          <p:cNvSpPr txBox="1"/>
          <p:nvPr/>
        </p:nvSpPr>
        <p:spPr>
          <a:xfrm>
            <a:off x="4146483" y="6906"/>
            <a:ext cx="14127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(b) 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52CA7D7-C23F-1766-0059-AF1164210DE0}"/>
              </a:ext>
            </a:extLst>
          </p:cNvPr>
          <p:cNvSpPr txBox="1"/>
          <p:nvPr/>
        </p:nvSpPr>
        <p:spPr>
          <a:xfrm>
            <a:off x="8077881" y="6906"/>
            <a:ext cx="14127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(c) 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2B31103-6429-55D3-406A-9BDE4CD256DC}"/>
              </a:ext>
            </a:extLst>
          </p:cNvPr>
          <p:cNvSpPr txBox="1"/>
          <p:nvPr/>
        </p:nvSpPr>
        <p:spPr>
          <a:xfrm>
            <a:off x="1084794" y="931785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3.3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20E03A3-A5AB-3762-E824-8190F81ADDC3}"/>
              </a:ext>
            </a:extLst>
          </p:cNvPr>
          <p:cNvSpPr txBox="1"/>
          <p:nvPr/>
        </p:nvSpPr>
        <p:spPr>
          <a:xfrm>
            <a:off x="1072919" y="2366984"/>
            <a:ext cx="1024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8.9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0F6EE6B-1594-DCEF-C474-E933BAF508AB}"/>
              </a:ext>
            </a:extLst>
          </p:cNvPr>
          <p:cNvSpPr txBox="1"/>
          <p:nvPr/>
        </p:nvSpPr>
        <p:spPr>
          <a:xfrm>
            <a:off x="1084794" y="603252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.8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CDFFF39-01C0-C1D3-A257-9C24CA88F0A0}"/>
              </a:ext>
            </a:extLst>
          </p:cNvPr>
          <p:cNvSpPr txBox="1"/>
          <p:nvPr/>
        </p:nvSpPr>
        <p:spPr>
          <a:xfrm>
            <a:off x="2098986" y="718030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8.7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82A8288-F291-EF49-A362-22BCF943A363}"/>
              </a:ext>
            </a:extLst>
          </p:cNvPr>
          <p:cNvSpPr txBox="1"/>
          <p:nvPr/>
        </p:nvSpPr>
        <p:spPr>
          <a:xfrm>
            <a:off x="3124654" y="1014911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4.9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6CD0ECE-AD11-4098-8D50-9BBBCBAC97BB}"/>
              </a:ext>
            </a:extLst>
          </p:cNvPr>
          <p:cNvSpPr txBox="1"/>
          <p:nvPr/>
        </p:nvSpPr>
        <p:spPr>
          <a:xfrm>
            <a:off x="2110861" y="2200728"/>
            <a:ext cx="1024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8.4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AC69D12-D493-28AB-CC8F-CAF8CAB2E892}"/>
              </a:ext>
            </a:extLst>
          </p:cNvPr>
          <p:cNvSpPr txBox="1"/>
          <p:nvPr/>
        </p:nvSpPr>
        <p:spPr>
          <a:xfrm>
            <a:off x="3124654" y="2414484"/>
            <a:ext cx="1024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.6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BE34123-FEDE-F73D-A130-9E98F36095AA}"/>
              </a:ext>
            </a:extLst>
          </p:cNvPr>
          <p:cNvSpPr txBox="1"/>
          <p:nvPr/>
        </p:nvSpPr>
        <p:spPr>
          <a:xfrm>
            <a:off x="4999212" y="1020097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8.5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8467942A-D529-2A14-3A9A-9F555C19AF6B}"/>
              </a:ext>
            </a:extLst>
          </p:cNvPr>
          <p:cNvSpPr txBox="1"/>
          <p:nvPr/>
        </p:nvSpPr>
        <p:spPr>
          <a:xfrm>
            <a:off x="4999212" y="2431544"/>
            <a:ext cx="1024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3.7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CD8DCD5-5D38-DC2F-D9C8-19D65496898F}"/>
              </a:ext>
            </a:extLst>
          </p:cNvPr>
          <p:cNvSpPr txBox="1"/>
          <p:nvPr/>
        </p:nvSpPr>
        <p:spPr>
          <a:xfrm>
            <a:off x="6025279" y="877587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8.8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13005755-FA6D-2FA8-351A-1CFC4B7F91C6}"/>
              </a:ext>
            </a:extLst>
          </p:cNvPr>
          <p:cNvSpPr txBox="1"/>
          <p:nvPr/>
        </p:nvSpPr>
        <p:spPr>
          <a:xfrm>
            <a:off x="7050947" y="1067599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8.4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BFD07D2-3E6E-1E18-F98F-75F2E0AF7D69}"/>
              </a:ext>
            </a:extLst>
          </p:cNvPr>
          <p:cNvSpPr txBox="1"/>
          <p:nvPr/>
        </p:nvSpPr>
        <p:spPr>
          <a:xfrm>
            <a:off x="6025279" y="2360292"/>
            <a:ext cx="1024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8.3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DD3D104-0DAE-09EF-875B-50165DDFD1D9}"/>
              </a:ext>
            </a:extLst>
          </p:cNvPr>
          <p:cNvSpPr txBox="1"/>
          <p:nvPr/>
        </p:nvSpPr>
        <p:spPr>
          <a:xfrm>
            <a:off x="7039072" y="2455296"/>
            <a:ext cx="1024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.1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9542221-ACBD-BC4A-AECC-875988251F8B}"/>
              </a:ext>
            </a:extLst>
          </p:cNvPr>
          <p:cNvSpPr txBox="1"/>
          <p:nvPr/>
        </p:nvSpPr>
        <p:spPr>
          <a:xfrm>
            <a:off x="8926945" y="889468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0.0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749644C-C58E-023F-350E-220ED925CBCC}"/>
              </a:ext>
            </a:extLst>
          </p:cNvPr>
          <p:cNvSpPr txBox="1"/>
          <p:nvPr/>
        </p:nvSpPr>
        <p:spPr>
          <a:xfrm>
            <a:off x="8926945" y="2300915"/>
            <a:ext cx="1024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2.2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E3E70426-59D2-EBE7-0715-312690B9C0E7}"/>
              </a:ext>
            </a:extLst>
          </p:cNvPr>
          <p:cNvSpPr txBox="1"/>
          <p:nvPr/>
        </p:nvSpPr>
        <p:spPr>
          <a:xfrm>
            <a:off x="9941137" y="758837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11.6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9A92F8E2-383D-4115-457A-9CB87F00C58B}"/>
              </a:ext>
            </a:extLst>
          </p:cNvPr>
          <p:cNvSpPr txBox="1"/>
          <p:nvPr/>
        </p:nvSpPr>
        <p:spPr>
          <a:xfrm>
            <a:off x="10966805" y="925091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9.5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E8A8A515-A743-0641-F525-507C32ECCBF1}"/>
              </a:ext>
            </a:extLst>
          </p:cNvPr>
          <p:cNvSpPr txBox="1"/>
          <p:nvPr/>
        </p:nvSpPr>
        <p:spPr>
          <a:xfrm>
            <a:off x="9953012" y="2253415"/>
            <a:ext cx="1024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.5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36B3AD6-63F7-C038-6331-4444B8D2DCCC}"/>
              </a:ext>
            </a:extLst>
          </p:cNvPr>
          <p:cNvSpPr txBox="1"/>
          <p:nvPr/>
        </p:nvSpPr>
        <p:spPr>
          <a:xfrm>
            <a:off x="10966805" y="2324665"/>
            <a:ext cx="1024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1.1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1E33CA2-76A3-B838-9B68-D4690A559FE7}"/>
              </a:ext>
            </a:extLst>
          </p:cNvPr>
          <p:cNvSpPr txBox="1"/>
          <p:nvPr/>
        </p:nvSpPr>
        <p:spPr>
          <a:xfrm>
            <a:off x="3124654" y="636492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.5</a:t>
            </a: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4DC8F32E-C742-3ACF-A2F4-84E84E327925}"/>
              </a:ext>
            </a:extLst>
          </p:cNvPr>
          <p:cNvSpPr txBox="1"/>
          <p:nvPr/>
        </p:nvSpPr>
        <p:spPr>
          <a:xfrm>
            <a:off x="5003328" y="602877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.8</a:t>
            </a: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849C8D5-494D-9FCE-35F7-FC638225A2E5}"/>
              </a:ext>
            </a:extLst>
          </p:cNvPr>
          <p:cNvSpPr txBox="1"/>
          <p:nvPr/>
        </p:nvSpPr>
        <p:spPr>
          <a:xfrm>
            <a:off x="7043188" y="624238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.5</a:t>
            </a: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4C151D0A-EA1E-6661-4023-A2D7D73FF3EC}"/>
              </a:ext>
            </a:extLst>
          </p:cNvPr>
          <p:cNvSpPr txBox="1"/>
          <p:nvPr/>
        </p:nvSpPr>
        <p:spPr>
          <a:xfrm>
            <a:off x="8921814" y="602877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.8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3CE40D6-8DDB-9D36-1D3E-D0FF88652DC1}"/>
              </a:ext>
            </a:extLst>
          </p:cNvPr>
          <p:cNvSpPr txBox="1"/>
          <p:nvPr/>
        </p:nvSpPr>
        <p:spPr>
          <a:xfrm>
            <a:off x="10961674" y="624238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.5</a:t>
            </a: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BCC797E2-A9E2-5169-B610-8B0728CC6059}"/>
              </a:ext>
            </a:extLst>
          </p:cNvPr>
          <p:cNvSpPr txBox="1"/>
          <p:nvPr/>
        </p:nvSpPr>
        <p:spPr>
          <a:xfrm>
            <a:off x="2539970" y="249823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9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41EAEAA-94B9-5977-D354-1A5D39F2C565}"/>
              </a:ext>
            </a:extLst>
          </p:cNvPr>
          <p:cNvSpPr txBox="1"/>
          <p:nvPr/>
        </p:nvSpPr>
        <p:spPr>
          <a:xfrm rot="16200000">
            <a:off x="-1665211" y="2204534"/>
            <a:ext cx="37987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portion of cases 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8F16130-0B9E-8CDB-579A-4716403C55B2}"/>
              </a:ext>
            </a:extLst>
          </p:cNvPr>
          <p:cNvSpPr txBox="1"/>
          <p:nvPr/>
        </p:nvSpPr>
        <p:spPr>
          <a:xfrm>
            <a:off x="1084794" y="4177733"/>
            <a:ext cx="1024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270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ACB4B3B-929D-80A2-D822-825065C8DB40}"/>
              </a:ext>
            </a:extLst>
          </p:cNvPr>
          <p:cNvSpPr txBox="1"/>
          <p:nvPr/>
        </p:nvSpPr>
        <p:spPr>
          <a:xfrm>
            <a:off x="3124654" y="4177733"/>
            <a:ext cx="1024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201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2F3D46B-3CB3-9A2E-6AB8-B0D7F8B94C86}"/>
              </a:ext>
            </a:extLst>
          </p:cNvPr>
          <p:cNvSpPr txBox="1"/>
          <p:nvPr/>
        </p:nvSpPr>
        <p:spPr>
          <a:xfrm>
            <a:off x="2110861" y="4177733"/>
            <a:ext cx="1024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69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8B68CE4-9A1B-1378-2ED5-1DA93DDF48B4}"/>
              </a:ext>
            </a:extLst>
          </p:cNvPr>
          <p:cNvSpPr txBox="1"/>
          <p:nvPr/>
        </p:nvSpPr>
        <p:spPr>
          <a:xfrm>
            <a:off x="5002495" y="4177733"/>
            <a:ext cx="1024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270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4528326-3124-9A0D-D05A-CF9FC075AA7E}"/>
              </a:ext>
            </a:extLst>
          </p:cNvPr>
          <p:cNvSpPr txBox="1"/>
          <p:nvPr/>
        </p:nvSpPr>
        <p:spPr>
          <a:xfrm>
            <a:off x="7050947" y="4177733"/>
            <a:ext cx="1024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201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28AA366-2097-4C7D-C50F-941504D82C8D}"/>
              </a:ext>
            </a:extLst>
          </p:cNvPr>
          <p:cNvSpPr txBox="1"/>
          <p:nvPr/>
        </p:nvSpPr>
        <p:spPr>
          <a:xfrm>
            <a:off x="6026721" y="4177733"/>
            <a:ext cx="1024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69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6174232-2CA4-990E-2E96-B82003E2B05F}"/>
              </a:ext>
            </a:extLst>
          </p:cNvPr>
          <p:cNvSpPr txBox="1"/>
          <p:nvPr/>
        </p:nvSpPr>
        <p:spPr>
          <a:xfrm>
            <a:off x="8930228" y="4177733"/>
            <a:ext cx="1024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270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A904797-0166-B2B3-CEEE-AE43308E5E9B}"/>
              </a:ext>
            </a:extLst>
          </p:cNvPr>
          <p:cNvSpPr txBox="1"/>
          <p:nvPr/>
        </p:nvSpPr>
        <p:spPr>
          <a:xfrm>
            <a:off x="10978680" y="4177733"/>
            <a:ext cx="1024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201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6C8B223-A041-80BF-E0BB-50F58021308D}"/>
              </a:ext>
            </a:extLst>
          </p:cNvPr>
          <p:cNvSpPr txBox="1"/>
          <p:nvPr/>
        </p:nvSpPr>
        <p:spPr>
          <a:xfrm>
            <a:off x="9954454" y="4177733"/>
            <a:ext cx="1024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69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8D574D91-F406-934E-105D-F49576990F64}"/>
              </a:ext>
            </a:extLst>
          </p:cNvPr>
          <p:cNvCxnSpPr>
            <a:cxnSpLocks/>
          </p:cNvCxnSpPr>
          <p:nvPr/>
        </p:nvCxnSpPr>
        <p:spPr>
          <a:xfrm flipV="1">
            <a:off x="2607596" y="577212"/>
            <a:ext cx="408846" cy="1588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619A83B8-BE85-D041-BFA2-474180FFA2DF}"/>
              </a:ext>
            </a:extLst>
          </p:cNvPr>
          <p:cNvSpPr txBox="1"/>
          <p:nvPr/>
        </p:nvSpPr>
        <p:spPr>
          <a:xfrm>
            <a:off x="6458502" y="249823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9</a:t>
            </a: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A875C6E1-7D2A-D574-7EDF-63E0290BAEB3}"/>
              </a:ext>
            </a:extLst>
          </p:cNvPr>
          <p:cNvCxnSpPr>
            <a:cxnSpLocks/>
          </p:cNvCxnSpPr>
          <p:nvPr/>
        </p:nvCxnSpPr>
        <p:spPr>
          <a:xfrm flipV="1">
            <a:off x="6526128" y="577212"/>
            <a:ext cx="408846" cy="1588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A03E3A8D-5547-96EA-2770-C6A89EE3A88E}"/>
              </a:ext>
            </a:extLst>
          </p:cNvPr>
          <p:cNvSpPr txBox="1"/>
          <p:nvPr/>
        </p:nvSpPr>
        <p:spPr>
          <a:xfrm>
            <a:off x="10377034" y="249823"/>
            <a:ext cx="1024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9</a:t>
            </a: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9B47AD10-2302-A5C8-C5B9-7A5C7C9FA98C}"/>
              </a:ext>
            </a:extLst>
          </p:cNvPr>
          <p:cNvCxnSpPr>
            <a:cxnSpLocks/>
          </p:cNvCxnSpPr>
          <p:nvPr/>
        </p:nvCxnSpPr>
        <p:spPr>
          <a:xfrm flipV="1">
            <a:off x="10444660" y="577212"/>
            <a:ext cx="408846" cy="1588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E9CCF1CF-A0D0-1C04-3B8E-D98AC9B382C6}"/>
              </a:ext>
            </a:extLst>
          </p:cNvPr>
          <p:cNvSpPr/>
          <p:nvPr/>
        </p:nvSpPr>
        <p:spPr>
          <a:xfrm>
            <a:off x="171341" y="5046388"/>
            <a:ext cx="144000" cy="144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E4F9D1D3-3ED5-87DE-78C9-24BFA322ED2F}"/>
              </a:ext>
            </a:extLst>
          </p:cNvPr>
          <p:cNvSpPr/>
          <p:nvPr/>
        </p:nvSpPr>
        <p:spPr>
          <a:xfrm>
            <a:off x="171341" y="6465846"/>
            <a:ext cx="144000" cy="1440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AEEC03C6-AF4A-A072-224A-33B7A3F3BEA9}"/>
              </a:ext>
            </a:extLst>
          </p:cNvPr>
          <p:cNvSpPr txBox="1"/>
          <p:nvPr/>
        </p:nvSpPr>
        <p:spPr>
          <a:xfrm>
            <a:off x="333078" y="4828565"/>
            <a:ext cx="3418168" cy="579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s meeting neither JSOG 2024</a:t>
            </a:r>
          </a:p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r Rotterdam/IEBG 2023 </a:t>
            </a:r>
            <a:endParaRPr kumimoji="1" lang="ja-JP" altLang="en-US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086DD14E-2398-4760-B659-0A121DC6C167}"/>
              </a:ext>
            </a:extLst>
          </p:cNvPr>
          <p:cNvSpPr txBox="1"/>
          <p:nvPr/>
        </p:nvSpPr>
        <p:spPr>
          <a:xfrm>
            <a:off x="333078" y="6369852"/>
            <a:ext cx="3106991" cy="3359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s meeting JSOG 2024</a:t>
            </a: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F0342ACA-A76D-3D6B-F9D1-DD06BA29AFE4}"/>
              </a:ext>
            </a:extLst>
          </p:cNvPr>
          <p:cNvSpPr/>
          <p:nvPr/>
        </p:nvSpPr>
        <p:spPr>
          <a:xfrm>
            <a:off x="171341" y="5750765"/>
            <a:ext cx="144000" cy="144000"/>
          </a:xfrm>
          <a:prstGeom prst="rect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F5EF9610-16CE-A7F5-5780-DB1901C2C056}"/>
              </a:ext>
            </a:extLst>
          </p:cNvPr>
          <p:cNvSpPr txBox="1"/>
          <p:nvPr/>
        </p:nvSpPr>
        <p:spPr>
          <a:xfrm>
            <a:off x="333078" y="5411114"/>
            <a:ext cx="4029446" cy="823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s not meeting JSOG 2024</a:t>
            </a:r>
          </a:p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ut meeting Rotterdam/IEBG 2023</a:t>
            </a:r>
          </a:p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d on elevated serum AMH (level 2)</a:t>
            </a:r>
            <a:endParaRPr kumimoji="1" lang="ja-JP" altLang="en-US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CDEE667A-5F5D-DA23-FADE-6E9C1F72D376}"/>
              </a:ext>
            </a:extLst>
          </p:cNvPr>
          <p:cNvSpPr/>
          <p:nvPr/>
        </p:nvSpPr>
        <p:spPr>
          <a:xfrm>
            <a:off x="4350124" y="5046388"/>
            <a:ext cx="144000" cy="144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正方形/長方形 70">
            <a:extLst>
              <a:ext uri="{FF2B5EF4-FFF2-40B4-BE49-F238E27FC236}">
                <a16:creationId xmlns:a16="http://schemas.microsoft.com/office/drawing/2014/main" id="{F18F43A1-EB66-5B06-7A13-947C47E9E081}"/>
              </a:ext>
            </a:extLst>
          </p:cNvPr>
          <p:cNvSpPr/>
          <p:nvPr/>
        </p:nvSpPr>
        <p:spPr>
          <a:xfrm>
            <a:off x="4350124" y="6465846"/>
            <a:ext cx="144000" cy="1440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7C8D840B-86AB-A592-FDCD-A903958C7A63}"/>
              </a:ext>
            </a:extLst>
          </p:cNvPr>
          <p:cNvSpPr txBox="1"/>
          <p:nvPr/>
        </p:nvSpPr>
        <p:spPr>
          <a:xfrm>
            <a:off x="4511860" y="4828565"/>
            <a:ext cx="3722597" cy="579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s meeting neither JSOG 2024</a:t>
            </a:r>
          </a:p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r Rotterdam/IEBG 2023</a:t>
            </a:r>
            <a:endParaRPr kumimoji="1" lang="ja-JP" altLang="en-US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44989DC-F79B-C71E-16A0-0556003C6048}"/>
              </a:ext>
            </a:extLst>
          </p:cNvPr>
          <p:cNvSpPr txBox="1"/>
          <p:nvPr/>
        </p:nvSpPr>
        <p:spPr>
          <a:xfrm>
            <a:off x="4511861" y="6248023"/>
            <a:ext cx="3902070" cy="579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s meeting Rotterdam/IEBG 2023</a:t>
            </a:r>
          </a:p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d on elevated serum AMH (level 2)</a:t>
            </a:r>
            <a:endParaRPr kumimoji="1" lang="ja-JP" altLang="en-US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A4A23D15-E0E6-7CC1-4A40-9215C5A73CE2}"/>
              </a:ext>
            </a:extLst>
          </p:cNvPr>
          <p:cNvSpPr/>
          <p:nvPr/>
        </p:nvSpPr>
        <p:spPr>
          <a:xfrm>
            <a:off x="4350124" y="5750765"/>
            <a:ext cx="144000" cy="144000"/>
          </a:xfrm>
          <a:prstGeom prst="rect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F881C70-57E0-5ED6-C3D4-4B478E377A35}"/>
              </a:ext>
            </a:extLst>
          </p:cNvPr>
          <p:cNvSpPr txBox="1"/>
          <p:nvPr/>
        </p:nvSpPr>
        <p:spPr>
          <a:xfrm>
            <a:off x="4511861" y="5411114"/>
            <a:ext cx="3601642" cy="823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s not meeting Rotterdam/IEBG</a:t>
            </a:r>
          </a:p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23 based on elevated serum AMH (level 2) but meeting JSOG 2024</a:t>
            </a:r>
          </a:p>
        </p:txBody>
      </p:sp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id="{812BC535-A0C8-71E3-026D-A33C41BF03A4}"/>
              </a:ext>
            </a:extLst>
          </p:cNvPr>
          <p:cNvSpPr/>
          <p:nvPr/>
        </p:nvSpPr>
        <p:spPr>
          <a:xfrm>
            <a:off x="8433237" y="5046388"/>
            <a:ext cx="144000" cy="144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id="{756E6088-30BE-1252-309C-D768421093A7}"/>
              </a:ext>
            </a:extLst>
          </p:cNvPr>
          <p:cNvSpPr/>
          <p:nvPr/>
        </p:nvSpPr>
        <p:spPr>
          <a:xfrm>
            <a:off x="8433237" y="6465846"/>
            <a:ext cx="144000" cy="1440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6CDE4940-3F4C-7314-0911-EC85D5041BB5}"/>
              </a:ext>
            </a:extLst>
          </p:cNvPr>
          <p:cNvSpPr txBox="1"/>
          <p:nvPr/>
        </p:nvSpPr>
        <p:spPr>
          <a:xfrm>
            <a:off x="8594974" y="4828565"/>
            <a:ext cx="3404266" cy="579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s meeting neither JSOG 2024</a:t>
            </a:r>
          </a:p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r Rotterdam/IEBG 2023</a:t>
            </a:r>
            <a:endParaRPr kumimoji="1" lang="ja-JP" altLang="en-US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43000C4B-10AB-CFC0-C098-D22916CEC22A}"/>
              </a:ext>
            </a:extLst>
          </p:cNvPr>
          <p:cNvSpPr txBox="1"/>
          <p:nvPr/>
        </p:nvSpPr>
        <p:spPr>
          <a:xfrm>
            <a:off x="8594974" y="6369852"/>
            <a:ext cx="3647793" cy="3359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s meeting Rotterdam/IEBG 2023</a:t>
            </a:r>
          </a:p>
        </p:txBody>
      </p:sp>
      <p:sp>
        <p:nvSpPr>
          <p:cNvPr id="80" name="正方形/長方形 79">
            <a:extLst>
              <a:ext uri="{FF2B5EF4-FFF2-40B4-BE49-F238E27FC236}">
                <a16:creationId xmlns:a16="http://schemas.microsoft.com/office/drawing/2014/main" id="{37D6F87C-8628-A2F8-39E8-02986A72A7B6}"/>
              </a:ext>
            </a:extLst>
          </p:cNvPr>
          <p:cNvSpPr/>
          <p:nvPr/>
        </p:nvSpPr>
        <p:spPr>
          <a:xfrm>
            <a:off x="8433237" y="5750765"/>
            <a:ext cx="144000" cy="144000"/>
          </a:xfrm>
          <a:prstGeom prst="rect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9F2315BB-2D34-7B12-F620-559D70C46C96}"/>
              </a:ext>
            </a:extLst>
          </p:cNvPr>
          <p:cNvSpPr txBox="1"/>
          <p:nvPr/>
        </p:nvSpPr>
        <p:spPr>
          <a:xfrm>
            <a:off x="8594974" y="5411114"/>
            <a:ext cx="3511421" cy="823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s not meeting Rotterdam/IEBG</a:t>
            </a:r>
          </a:p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23 but meeting JSOG 2024</a:t>
            </a:r>
          </a:p>
          <a:p>
            <a:pPr>
              <a:lnSpc>
                <a:spcPts val="1860"/>
              </a:lnSpc>
            </a:pPr>
            <a:r>
              <a:rPr kumimoji="1" lang="en" altLang="ja-JP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d on high LH</a:t>
            </a:r>
            <a:endParaRPr kumimoji="1" lang="ja-JP" altLang="en-US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9470213"/>
      </p:ext>
    </p:extLst>
  </p:cSld>
  <p:clrMapOvr>
    <a:masterClrMapping/>
  </p:clrMapOvr>
</p:sld>
</file>

<file path=ppt/theme/theme1.xml><?xml version="1.0" encoding="utf-8"?>
<a:theme xmlns:a="http://schemas.openxmlformats.org/drawingml/2006/main" name="HDOfficeLightV0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2947</TotalTime>
  <Words>531</Words>
  <Application>Microsoft Macintosh PowerPoint</Application>
  <PresentationFormat>ワイド画面</PresentationFormat>
  <Paragraphs>6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Calibri</vt:lpstr>
      <vt:lpstr>Calibri Light</vt:lpstr>
      <vt:lpstr>Times New Roman</vt:lpstr>
      <vt:lpstr>Wingdings 2</vt:lpstr>
      <vt:lpstr>HDOfficeLightV0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野口　拓樹</cp:lastModifiedBy>
  <cp:revision>980</cp:revision>
  <cp:lastPrinted>2022-12-04T21:39:05Z</cp:lastPrinted>
  <dcterms:created xsi:type="dcterms:W3CDTF">2020-09-11T04:04:24Z</dcterms:created>
  <dcterms:modified xsi:type="dcterms:W3CDTF">2026-03-29T09:58:51Z</dcterms:modified>
</cp:coreProperties>
</file>